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218238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>
        <p:scale>
          <a:sx n="150" d="100"/>
          <a:sy n="150" d="100"/>
        </p:scale>
        <p:origin x="177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8" y="1272011"/>
            <a:ext cx="5285502" cy="2705947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082310"/>
            <a:ext cx="4663679" cy="1876530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286601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508049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13808"/>
            <a:ext cx="1340808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13808"/>
            <a:ext cx="3944695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095490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79232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1937705"/>
            <a:ext cx="5363230" cy="3233102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201393"/>
            <a:ext cx="5363230" cy="1700212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>
                    <a:tint val="82000"/>
                  </a:schemeClr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82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31537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4" y="2069042"/>
            <a:ext cx="2642751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3" y="2069042"/>
            <a:ext cx="2642751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728023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13810"/>
            <a:ext cx="536323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4" y="1905318"/>
            <a:ext cx="2630606" cy="933767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4" y="2839085"/>
            <a:ext cx="2630606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3" y="1905318"/>
            <a:ext cx="2643561" cy="933767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3" y="2839085"/>
            <a:ext cx="2643561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254868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41289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805548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518160"/>
            <a:ext cx="2005544" cy="181356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1" y="1119083"/>
            <a:ext cx="3147983" cy="5523442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4" y="2331720"/>
            <a:ext cx="2005544" cy="4319800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658249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518160"/>
            <a:ext cx="2005544" cy="181356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1" y="1119083"/>
            <a:ext cx="3147983" cy="5523442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4" y="2331720"/>
            <a:ext cx="2005544" cy="4319800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19973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13810"/>
            <a:ext cx="536323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069042"/>
            <a:ext cx="536323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4" y="7203865"/>
            <a:ext cx="1399104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8345CD-AFF4-4C68-8C0F-28BDCDAD0CDD}" type="datetimeFigureOut">
              <a:rPr lang="fr-BE" smtClean="0"/>
              <a:t>09-08-24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2" y="7203865"/>
            <a:ext cx="2098655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0" y="7203865"/>
            <a:ext cx="1399104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D71959E-C4E9-4646-971B-4F8AD9F2E632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585878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CB3AEB7-5651-F9EF-DB90-C26C8FF371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DDDCE97-7C7B-9EC5-A31A-54F0A60D2E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5048932"/>
              </p:ext>
            </p:extLst>
          </p:nvPr>
        </p:nvGraphicFramePr>
        <p:xfrm>
          <a:off x="1051859" y="776318"/>
          <a:ext cx="4114801" cy="2202047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986423">
                  <a:extLst>
                    <a:ext uri="{9D8B030D-6E8A-4147-A177-3AD203B41FA5}">
                      <a16:colId xmlns:a16="http://schemas.microsoft.com/office/drawing/2014/main" val="467969234"/>
                    </a:ext>
                  </a:extLst>
                </a:gridCol>
                <a:gridCol w="718682">
                  <a:extLst>
                    <a:ext uri="{9D8B030D-6E8A-4147-A177-3AD203B41FA5}">
                      <a16:colId xmlns:a16="http://schemas.microsoft.com/office/drawing/2014/main" val="2236806544"/>
                    </a:ext>
                  </a:extLst>
                </a:gridCol>
                <a:gridCol w="718682">
                  <a:extLst>
                    <a:ext uri="{9D8B030D-6E8A-4147-A177-3AD203B41FA5}">
                      <a16:colId xmlns:a16="http://schemas.microsoft.com/office/drawing/2014/main" val="4229112849"/>
                    </a:ext>
                  </a:extLst>
                </a:gridCol>
                <a:gridCol w="972332">
                  <a:extLst>
                    <a:ext uri="{9D8B030D-6E8A-4147-A177-3AD203B41FA5}">
                      <a16:colId xmlns:a16="http://schemas.microsoft.com/office/drawing/2014/main" val="253613443"/>
                    </a:ext>
                  </a:extLst>
                </a:gridCol>
                <a:gridCol w="718682">
                  <a:extLst>
                    <a:ext uri="{9D8B030D-6E8A-4147-A177-3AD203B41FA5}">
                      <a16:colId xmlns:a16="http://schemas.microsoft.com/office/drawing/2014/main" val="2075968188"/>
                    </a:ext>
                  </a:extLst>
                </a:gridCol>
              </a:tblGrid>
              <a:tr h="231401">
                <a:tc>
                  <a:txBody>
                    <a:bodyPr/>
                    <a:lstStyle/>
                    <a:p>
                      <a:pPr algn="ctr" fontAlgn="b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8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patients</a:t>
                      </a:r>
                      <a:endParaRPr lang="fr-B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</a:t>
                      </a:r>
                      <a:endParaRPr lang="fr-B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CI</a:t>
                      </a:r>
                      <a:endParaRPr lang="fr-B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1000" i="1" u="sng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fr-BE" sz="1000" b="0" i="1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3341754"/>
                  </a:ext>
                </a:extLst>
              </a:tr>
              <a:tr h="231401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FM32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0.62 ; 0.99]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001**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588476619"/>
                  </a:ext>
                </a:extLst>
              </a:tr>
              <a:tr h="231401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FMSE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0.98 ; 0.99]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*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182064157"/>
                  </a:ext>
                </a:extLst>
              </a:tr>
              <a:tr h="231401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MWT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0.04 - 1]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*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860873795"/>
                  </a:ext>
                </a:extLst>
              </a:tr>
              <a:tr h="231401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NE-2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0 ; 1]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571075825"/>
                  </a:ext>
                </a:extLst>
              </a:tr>
              <a:tr h="350839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P-INTEND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902849884"/>
                  </a:ext>
                </a:extLst>
              </a:tr>
              <a:tr h="231401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P-L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62101223"/>
                  </a:ext>
                </a:extLst>
              </a:tr>
              <a:tr h="231401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P-R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629309116"/>
                  </a:ext>
                </a:extLst>
              </a:tr>
              <a:tr h="231401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TN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3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63 ; 0.25]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723422248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CB01E021-54B0-9BA4-748D-6C7FF46167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2621058"/>
              </p:ext>
            </p:extLst>
          </p:nvPr>
        </p:nvGraphicFramePr>
        <p:xfrm>
          <a:off x="1051719" y="3519097"/>
          <a:ext cx="4114801" cy="2286000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986423">
                  <a:extLst>
                    <a:ext uri="{9D8B030D-6E8A-4147-A177-3AD203B41FA5}">
                      <a16:colId xmlns:a16="http://schemas.microsoft.com/office/drawing/2014/main" val="187938588"/>
                    </a:ext>
                  </a:extLst>
                </a:gridCol>
                <a:gridCol w="718682">
                  <a:extLst>
                    <a:ext uri="{9D8B030D-6E8A-4147-A177-3AD203B41FA5}">
                      <a16:colId xmlns:a16="http://schemas.microsoft.com/office/drawing/2014/main" val="3184577091"/>
                    </a:ext>
                  </a:extLst>
                </a:gridCol>
                <a:gridCol w="718682">
                  <a:extLst>
                    <a:ext uri="{9D8B030D-6E8A-4147-A177-3AD203B41FA5}">
                      <a16:colId xmlns:a16="http://schemas.microsoft.com/office/drawing/2014/main" val="3275436181"/>
                    </a:ext>
                  </a:extLst>
                </a:gridCol>
                <a:gridCol w="972332">
                  <a:extLst>
                    <a:ext uri="{9D8B030D-6E8A-4147-A177-3AD203B41FA5}">
                      <a16:colId xmlns:a16="http://schemas.microsoft.com/office/drawing/2014/main" val="4207689791"/>
                    </a:ext>
                  </a:extLst>
                </a:gridCol>
                <a:gridCol w="718682">
                  <a:extLst>
                    <a:ext uri="{9D8B030D-6E8A-4147-A177-3AD203B41FA5}">
                      <a16:colId xmlns:a16="http://schemas.microsoft.com/office/drawing/2014/main" val="1165796727"/>
                    </a:ext>
                  </a:extLst>
                </a:gridCol>
              </a:tblGrid>
              <a:tr h="285750">
                <a:tc>
                  <a:txBody>
                    <a:bodyPr/>
                    <a:lstStyle/>
                    <a:p>
                      <a:pPr algn="ctr" fontAlgn="b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TN</a:t>
                      </a: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patients</a:t>
                      </a:r>
                      <a:endParaRPr lang="fr-B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</a:t>
                      </a:r>
                      <a:endParaRPr lang="fr-B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CI</a:t>
                      </a:r>
                      <a:endParaRPr lang="fr-B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fr-BE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3531461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FM32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76 ; 0.44]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44309421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FMSE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7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80 ; 0.64]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242698095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MWT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66 ; 0.72]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466097878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NE-2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8 ; 1]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443676631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P-INTEND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576323241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P-L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4682169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P-R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fr-B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071828293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7400B342-8BEB-F850-3439-180871F77953}"/>
              </a:ext>
            </a:extLst>
          </p:cNvPr>
          <p:cNvSpPr txBox="1"/>
          <p:nvPr/>
        </p:nvSpPr>
        <p:spPr>
          <a:xfrm>
            <a:off x="1" y="161362"/>
            <a:ext cx="6125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. Correlation between GDF8, FSTN and motor scores at 18 months of treatment with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nusinersen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B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8967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7</Words>
  <Application>Microsoft Office PowerPoint</Application>
  <PresentationFormat>Custom</PresentationFormat>
  <Paragraphs>8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ne Mackels</dc:creator>
  <cp:lastModifiedBy>MDPI-023</cp:lastModifiedBy>
  <cp:revision>40</cp:revision>
  <dcterms:created xsi:type="dcterms:W3CDTF">2024-03-19T13:08:48Z</dcterms:created>
  <dcterms:modified xsi:type="dcterms:W3CDTF">2024-08-09T17:25:51Z</dcterms:modified>
</cp:coreProperties>
</file>